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customXml/itemProps1.xml" ContentType="application/vnd.openxmlformats-officedocument.customXmlProperties+xml"/>
  <Default Extension="wmf" ContentType="image/x-wmf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  <Default Extension="bin" ContentType="application/vnd.openxmlformats-officedocument.oleObject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emf" ContentType="image/x-emf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321" r:id="rId2"/>
    <p:sldId id="291" r:id="rId3"/>
    <p:sldId id="339" r:id="rId4"/>
    <p:sldId id="303" r:id="rId5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400">
          <p15:clr>
            <a:srgbClr val="A4A3A4"/>
          </p15:clr>
        </p15:guide>
        <p15:guide id="2" pos="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07" autoAdjust="0"/>
    <p:restoredTop sz="87129" autoAdjust="0"/>
  </p:normalViewPr>
  <p:slideViewPr>
    <p:cSldViewPr showGuides="1">
      <p:cViewPr>
        <p:scale>
          <a:sx n="85" d="100"/>
          <a:sy n="85" d="100"/>
        </p:scale>
        <p:origin x="-1134" y="-72"/>
      </p:cViewPr>
      <p:guideLst>
        <p:guide orient="horz" pos="2304"/>
        <p:guide pos="9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26622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56795" y="0"/>
            <a:ext cx="3026622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6FF096-C3D3-41F5-A758-2E14381B738F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18563"/>
            <a:ext cx="3026622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56795" y="8818563"/>
            <a:ext cx="3026622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85B8CF-FA4A-40CC-9FF8-85D6DBE86AC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77504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3026833" cy="464185"/>
          </a:xfrm>
          <a:prstGeom prst="rect">
            <a:avLst/>
          </a:prstGeom>
        </p:spPr>
        <p:txBody>
          <a:bodyPr vert="horz" lIns="93031" tIns="46516" rIns="93031" bIns="465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1"/>
            <a:ext cx="3026833" cy="464185"/>
          </a:xfrm>
          <a:prstGeom prst="rect">
            <a:avLst/>
          </a:prstGeom>
        </p:spPr>
        <p:txBody>
          <a:bodyPr vert="horz" lIns="93031" tIns="46516" rIns="93031" bIns="46516" rtlCol="0"/>
          <a:lstStyle>
            <a:lvl1pPr algn="r">
              <a:defRPr sz="1200"/>
            </a:lvl1pPr>
          </a:lstStyle>
          <a:p>
            <a:fld id="{F002061D-1FA4-4626-9CBE-DB745543A390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031" tIns="46516" rIns="93031" bIns="4651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1" y="4409758"/>
            <a:ext cx="5588000" cy="4177665"/>
          </a:xfrm>
          <a:prstGeom prst="rect">
            <a:avLst/>
          </a:prstGeom>
        </p:spPr>
        <p:txBody>
          <a:bodyPr vert="horz" lIns="93031" tIns="46516" rIns="93031" bIns="4651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8817904"/>
            <a:ext cx="3026833" cy="464185"/>
          </a:xfrm>
          <a:prstGeom prst="rect">
            <a:avLst/>
          </a:prstGeom>
        </p:spPr>
        <p:txBody>
          <a:bodyPr vert="horz" lIns="93031" tIns="46516" rIns="93031" bIns="465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4"/>
            <a:ext cx="3026833" cy="464185"/>
          </a:xfrm>
          <a:prstGeom prst="rect">
            <a:avLst/>
          </a:prstGeom>
        </p:spPr>
        <p:txBody>
          <a:bodyPr vert="horz" lIns="93031" tIns="46516" rIns="93031" bIns="46516" rtlCol="0" anchor="b"/>
          <a:lstStyle>
            <a:lvl1pPr algn="r">
              <a:defRPr sz="1200"/>
            </a:lvl1pPr>
          </a:lstStyle>
          <a:p>
            <a:fld id="{B95D3B45-9C4C-4AF4-AF33-E97EC1479B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853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5D3B45-9C4C-4AF4-AF33-E97EC1479BE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468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ptimization of a method for the isolation of gastric LPM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Shown are the number of viable cells per mg of tissue obtained from the recommended settings for BB homogenization and the optimized settings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omparison of viable cell yields obtained by a conventional method (enzyme digestion and mechanical dissociation) and the optimized method described in this manuscript (enzymatic digestion and Bullet blender (BB) homogenization)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omparison of the effects of digestion of gastric biopsies and PBMC with either collagenase D 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pas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nzymes on cell surface markers.  Shown are the MFI (Mean fluorescent intensity) for T cells surface markers (CD4 and CD8) in both LPMC and PBMC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Effects of collagenase D on T cell surface markers. Shown are the percentage of positive cells expressing CD3, CD4, CD8, CD62L, CD45RA and integrin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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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7 in PBMC following treatment with either a digestion mix containing collagenase D (SD) or with a digestion mix without collagenase D (SD-C). The following CD4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CD8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sets were analyzed: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M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T central memory; 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T naïve; 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T effector memory; 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R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3B103C-52FA-4789-9260-E69F9BD4DCDD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0775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Comparison of cytokine levels between normal and “mild inflammation” gastric pathology volunteers. (A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mulative data comparing baseline activation levels of gastric LPMC CD8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btained from volunteers undergoing EGD where the reported diagnostic pathology of the stomach is normal (n=12) or exhibited mild inflammation (n=23) (reactive changes, mild diffuse erythema/inflammation)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umulative data comparing baseline activation levels of gastric LPMC CD4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btained from volunteers undergoing EGD where the reported diagnostic pathology of the stomach is normal (n=12) or exhibited mild inflammation (n=23) (reactive changes, mild diffuse erythema/inflammation). Bars represent mean (± SEM) of each cytokine/chemokine. No statistical significance in cytokine levels was detected between the normal and the mild inflammation gastric pathology groups.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5D3B45-9C4C-4AF4-AF33-E97EC1479BE0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1688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1: Characterization of memory T (T</a:t>
            </a:r>
            <a:r>
              <a:rPr lang="en-US" sz="1200" b="1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ells in gastric LPMC and PBMC from adults, children and the elderly. (A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umulative data showing the median % and range of CD3, CD4, CD8, central memory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iv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R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D62L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45RA</a:t>
            </a:r>
            <a:r>
              <a:rPr lang="en-US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in gastric LPMC and PBMC from all age groups.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arison of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sets between LPMC and PBMC were evaluated and significant differences are shown in highlighted colors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reen=Significant increases in the percentages of cells in LPMC as compared to PBMC; Blue=Significant decreases in the percentages of cells in LPMC as compared to PBMC (*P&lt;0.05;**P&lt;0.005; ***P&lt;0.0005)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umulative data comparing the percentage of T</a:t>
            </a:r>
            <a:r>
              <a:rPr lang="en-US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sets between the age groups using adult as a reference (e.g., children vs adults or elderly vs adults). Significant differences are shown in highlighted colors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een=Significant increases in the percentages of cells in children or elderly as compared to adults; Blue=Significant decreases in the percentages of cells in children or elderly as compared to adults (*P&lt;0.05;**P&lt;0.005; ***P&lt;0.0005) (Adults: n=10; Children: n=10; elderly: n=10). </a:t>
            </a:r>
          </a:p>
          <a:p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5D3B45-9C4C-4AF4-AF33-E97EC1479BE0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0672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58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359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48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720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492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74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543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531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741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92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955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F3568-9457-48B1-BBAE-39ACD5DD290A}" type="datetimeFigureOut">
              <a:rPr lang="en-US" smtClean="0"/>
              <a:pPr/>
              <a:t>4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8C006-9508-49F4-9BC5-6453376F62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88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package" Target="../embeddings/Microsoft_Excel_Worksheet2.xlsx"/><Relationship Id="rId3" Type="http://schemas.openxmlformats.org/officeDocument/2006/relationships/notesSlide" Target="../notesSlides/notesSlide2.xml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image" Target="../media/image4.wmf"/><Relationship Id="rId5" Type="http://schemas.openxmlformats.org/officeDocument/2006/relationships/package" Target="../embeddings/Microsoft_Excel_Worksheet1.xlsx"/><Relationship Id="rId10" Type="http://schemas.openxmlformats.org/officeDocument/2006/relationships/image" Target="../media/image3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da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6313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7725600"/>
              </p:ext>
            </p:extLst>
          </p:nvPr>
        </p:nvGraphicFramePr>
        <p:xfrm>
          <a:off x="228600" y="1331109"/>
          <a:ext cx="4445053" cy="132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91" name="Worksheet" r:id="rId5" imgW="4381599" imgH="1171531" progId="Excel.Sheet.12">
                  <p:embed/>
                </p:oleObj>
              </mc:Choice>
              <mc:Fallback>
                <p:oleObj name="Worksheet" r:id="rId5" imgW="4381599" imgH="1171531" progId="Excel.Sheet.12">
                  <p:embed/>
                  <p:pic>
                    <p:nvPicPr>
                      <p:cNvPr id="0" name="Picture 44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8600" y="1331109"/>
                        <a:ext cx="4445053" cy="13239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228600" y="152400"/>
            <a:ext cx="8382000" cy="381000"/>
          </a:xfrm>
        </p:spPr>
        <p:txBody>
          <a:bodyPr rtlCol="0">
            <a:no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200" b="1" dirty="0" smtClean="0"/>
              <a:t>Figure </a:t>
            </a:r>
            <a:r>
              <a:rPr lang="en-US" sz="2200" dirty="0" smtClean="0"/>
              <a:t>S1. Optimization </a:t>
            </a:r>
            <a:r>
              <a:rPr lang="en-US" sz="2200" dirty="0"/>
              <a:t>of a method for the isolation of gastric LPMC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27475" y="84197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509621" y="838200"/>
            <a:ext cx="2909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35678" y="286199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537496" y="282254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1483632"/>
              </p:ext>
            </p:extLst>
          </p:nvPr>
        </p:nvGraphicFramePr>
        <p:xfrm>
          <a:off x="4749853" y="1371600"/>
          <a:ext cx="3705225" cy="1009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92" name="Worksheet" r:id="rId8" imgW="3705101" imgH="1009709" progId="Excel.Sheet.12">
                  <p:embed/>
                </p:oleObj>
              </mc:Choice>
              <mc:Fallback>
                <p:oleObj name="Worksheet" r:id="rId8" imgW="3705101" imgH="1009709" progId="Excel.Sheet.12">
                  <p:embed/>
                  <p:pic>
                    <p:nvPicPr>
                      <p:cNvPr id="0" name="Picture 44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49853" y="1371600"/>
                        <a:ext cx="3705225" cy="10096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864" name="Picture 33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5" y="3352800"/>
            <a:ext cx="3960813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970" name="Picture 442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64" t="9112" r="8234" b="6216"/>
          <a:stretch/>
        </p:blipFill>
        <p:spPr bwMode="auto">
          <a:xfrm>
            <a:off x="4334227" y="3206254"/>
            <a:ext cx="4694231" cy="32707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86953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792162"/>
          </a:xfrm>
        </p:spPr>
        <p:txBody>
          <a:bodyPr rtlCol="0">
            <a:no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200" b="1" dirty="0" smtClean="0"/>
              <a:t>Figure S2</a:t>
            </a:r>
            <a:r>
              <a:rPr lang="en-US" sz="2200" dirty="0" smtClean="0"/>
              <a:t>. Comparison of cytokine levels between normal and </a:t>
            </a:r>
            <a:r>
              <a:rPr lang="en-US" sz="2200" dirty="0" smtClean="0"/>
              <a:t>“mild inflammation” </a:t>
            </a:r>
            <a:r>
              <a:rPr lang="en-US" sz="2200" dirty="0" smtClean="0"/>
              <a:t>gastric pathology volunteers.</a:t>
            </a:r>
            <a:endParaRPr lang="en-US" sz="22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763" y="1778000"/>
            <a:ext cx="8626475" cy="330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21770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30411" y="9682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559920" y="968255"/>
            <a:ext cx="2909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228600" y="152400"/>
            <a:ext cx="8229600" cy="381000"/>
          </a:xfrm>
          <a:prstGeom prst="rect">
            <a:avLst/>
          </a:prstGeom>
        </p:spPr>
        <p:txBody>
          <a:bodyPr rtlCol="0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defRPr/>
            </a:pPr>
            <a:r>
              <a:rPr lang="en-US" sz="2000" b="1" dirty="0" smtClean="0"/>
              <a:t>Table </a:t>
            </a:r>
            <a:r>
              <a:rPr lang="en-US" sz="2000" b="1" dirty="0"/>
              <a:t>S1: </a:t>
            </a:r>
            <a:r>
              <a:rPr lang="en-US" sz="2000" dirty="0"/>
              <a:t>Characterization of memory T (T</a:t>
            </a:r>
            <a:r>
              <a:rPr lang="en-US" sz="2000" baseline="-25000" dirty="0"/>
              <a:t>M</a:t>
            </a:r>
            <a:r>
              <a:rPr lang="en-US" sz="2000" dirty="0"/>
              <a:t>) cells in gastric LPMC and PBMC from adults, children and the </a:t>
            </a:r>
            <a:r>
              <a:rPr lang="en-US" sz="2000" dirty="0" smtClean="0"/>
              <a:t>elderly</a:t>
            </a:r>
            <a:endParaRPr lang="en-US" sz="2400" dirty="0"/>
          </a:p>
        </p:txBody>
      </p:sp>
      <p:grpSp>
        <p:nvGrpSpPr>
          <p:cNvPr id="8" name="Group 7"/>
          <p:cNvGrpSpPr/>
          <p:nvPr/>
        </p:nvGrpSpPr>
        <p:grpSpPr>
          <a:xfrm>
            <a:off x="0" y="1386849"/>
            <a:ext cx="6135383" cy="4370596"/>
            <a:chOff x="0" y="970845"/>
            <a:chExt cx="6135383" cy="4370596"/>
          </a:xfrm>
        </p:grpSpPr>
        <p:pic>
          <p:nvPicPr>
            <p:cNvPr id="27653" name="Picture 5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3" t="3518" r="6753" b="20747"/>
            <a:stretch/>
          </p:blipFill>
          <p:spPr bwMode="auto">
            <a:xfrm>
              <a:off x="0" y="970845"/>
              <a:ext cx="6135383" cy="35793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76199" y="4572000"/>
              <a:ext cx="601522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baseline="30000" dirty="0" smtClean="0"/>
                <a:t>a</a:t>
              </a:r>
              <a:r>
                <a:rPr lang="en-US" sz="1100" b="1" dirty="0" smtClean="0"/>
                <a:t> Blue color  =  significant decrease in the percentage of a population in LPMC compared to PBMC</a:t>
              </a:r>
            </a:p>
            <a:p>
              <a:r>
                <a:rPr lang="en-US" sz="1100" b="1" baseline="30000" dirty="0" smtClean="0"/>
                <a:t>b</a:t>
              </a:r>
              <a:r>
                <a:rPr lang="en-US" sz="1100" b="1" dirty="0" smtClean="0"/>
                <a:t> Green </a:t>
              </a:r>
              <a:r>
                <a:rPr lang="en-US" sz="1100" b="1" dirty="0"/>
                <a:t>color  =  significant </a:t>
              </a:r>
              <a:r>
                <a:rPr lang="en-US" sz="1100" b="1" dirty="0" smtClean="0"/>
                <a:t>increase </a:t>
              </a:r>
              <a:r>
                <a:rPr lang="en-US" sz="1100" b="1" dirty="0"/>
                <a:t>in the percentage of a population in LPMC compared to </a:t>
              </a:r>
              <a:r>
                <a:rPr lang="en-US" sz="1100" b="1" dirty="0" smtClean="0"/>
                <a:t>PBMC</a:t>
              </a:r>
            </a:p>
            <a:p>
              <a:r>
                <a:rPr lang="en-US" sz="1100" b="1" dirty="0" smtClean="0"/>
                <a:t>*P&lt;0.05; ** P&lt;0.005; *** P&lt;0.0005</a:t>
              </a:r>
              <a:endParaRPr lang="en-US" sz="1100" b="1" dirty="0"/>
            </a:p>
            <a:p>
              <a:endParaRPr lang="en-US" sz="1100" b="1" dirty="0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6091421" y="1482804"/>
            <a:ext cx="3052579" cy="4384596"/>
            <a:chOff x="6091421" y="1066800"/>
            <a:chExt cx="3052579" cy="4384596"/>
          </a:xfrm>
        </p:grpSpPr>
        <p:pic>
          <p:nvPicPr>
            <p:cNvPr id="27655" name="Picture 7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40" t="3072" r="18490" b="20468"/>
            <a:stretch/>
          </p:blipFill>
          <p:spPr bwMode="auto">
            <a:xfrm>
              <a:off x="6091421" y="1066800"/>
              <a:ext cx="3052579" cy="33310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6324600" y="4343400"/>
              <a:ext cx="28194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baseline="30000" dirty="0" smtClean="0"/>
                <a:t>a</a:t>
              </a:r>
              <a:r>
                <a:rPr lang="en-US" sz="1100" b="1" dirty="0" smtClean="0"/>
                <a:t> Blue color  =  decrease in the percentage compared to adult</a:t>
              </a:r>
            </a:p>
            <a:p>
              <a:r>
                <a:rPr lang="en-US" sz="1100" b="1" baseline="30000" dirty="0" smtClean="0"/>
                <a:t>b</a:t>
              </a:r>
              <a:r>
                <a:rPr lang="en-US" sz="1100" b="1" dirty="0" smtClean="0"/>
                <a:t> Green </a:t>
              </a:r>
              <a:r>
                <a:rPr lang="en-US" sz="1100" b="1" dirty="0"/>
                <a:t>color  = </a:t>
              </a:r>
              <a:r>
                <a:rPr lang="en-US" sz="1100" b="1" dirty="0" smtClean="0"/>
                <a:t>increase </a:t>
              </a:r>
              <a:r>
                <a:rPr lang="en-US" sz="1100" b="1" dirty="0"/>
                <a:t>in the percentage </a:t>
              </a:r>
              <a:r>
                <a:rPr lang="en-US" sz="1100" b="1" dirty="0" smtClean="0"/>
                <a:t>compared </a:t>
              </a:r>
              <a:r>
                <a:rPr lang="en-US" sz="1100" b="1" dirty="0"/>
                <a:t>to </a:t>
              </a:r>
              <a:r>
                <a:rPr lang="en-US" sz="1100" b="1" dirty="0" smtClean="0"/>
                <a:t>adult</a:t>
              </a:r>
            </a:p>
            <a:p>
              <a:r>
                <a:rPr lang="en-US" sz="1100" b="1" dirty="0" smtClean="0"/>
                <a:t>*P&lt;0.05; ** P&lt;0.005; *** P&lt;0.0005</a:t>
              </a:r>
              <a:endParaRPr lang="en-US" sz="1100" b="1" dirty="0"/>
            </a:p>
            <a:p>
              <a:endParaRPr lang="en-US" sz="11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534471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rgbClr val="C00000"/>
          </a:solidFill>
          <a:tailEnd type="stealth"/>
        </a:ln>
      </a:spPr>
      <a:bodyPr rtlCol="0" anchor="ctr"/>
      <a:lstStyle>
        <a:defPPr algn="ctr">
          <a:defRPr sz="1400" b="1" dirty="0" smtClean="0">
            <a:solidFill>
              <a:srgbClr val="FF0000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F9D9197C5E49247BB3420E7F536A978" ma:contentTypeVersion="7" ma:contentTypeDescription="Create a new document." ma:contentTypeScope="" ma:versionID="4af6098475b9d2a52790565593fa18ee">
  <xsd:schema xmlns:xsd="http://www.w3.org/2001/XMLSchema" xmlns:p="http://schemas.microsoft.com/office/2006/metadata/properties" xmlns:ns2="1f2809b4-cdb6-4d27-85e1-333ec8200287" targetNamespace="http://schemas.microsoft.com/office/2006/metadata/properties" ma:root="true" ma:fieldsID="89577d04481b3a1fa4061352c44df483" ns2:_="">
    <xsd:import namespace="1f2809b4-cdb6-4d27-85e1-333ec820028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f2809b4-cdb6-4d27-85e1-333ec820028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1f2809b4-cdb6-4d27-85e1-333ec8200287">PPTX</FileFormat>
    <DocumentId xmlns="1f2809b4-cdb6-4d27-85e1-333ec8200287">Presentation 1.PPTX</DocumentId>
    <IsDeleted xmlns="1f2809b4-cdb6-4d27-85e1-333ec8200287">false</IsDeleted>
    <StageName xmlns="1f2809b4-cdb6-4d27-85e1-333ec8200287" xsi:nil="true"/>
    <Checked_x0020_Out_x0020_To xmlns="1f2809b4-cdb6-4d27-85e1-333ec8200287">
      <UserInfo>
        <DisplayName/>
        <AccountId xsi:nil="true"/>
        <AccountType/>
      </UserInfo>
    </Checked_x0020_Out_x0020_To>
    <TitleName xmlns="1f2809b4-cdb6-4d27-85e1-333ec8200287">Presentation 1.PPTX</TitleName>
    <DocumentType xmlns="1f2809b4-cdb6-4d27-85e1-333ec8200287">Presentation</DocumentType>
  </documentManagement>
</p:properties>
</file>

<file path=customXml/itemProps1.xml><?xml version="1.0" encoding="utf-8"?>
<ds:datastoreItem xmlns:ds="http://schemas.openxmlformats.org/officeDocument/2006/customXml" ds:itemID="{98691134-B67F-4FE0-BD9F-8187BB162C50}"/>
</file>

<file path=customXml/itemProps2.xml><?xml version="1.0" encoding="utf-8"?>
<ds:datastoreItem xmlns:ds="http://schemas.openxmlformats.org/officeDocument/2006/customXml" ds:itemID="{4E159EF2-1894-43CD-94D5-36B1BD13EEFA}"/>
</file>

<file path=customXml/itemProps3.xml><?xml version="1.0" encoding="utf-8"?>
<ds:datastoreItem xmlns:ds="http://schemas.openxmlformats.org/officeDocument/2006/customXml" ds:itemID="{4D62FDFF-78AB-49E3-8341-418108EF5EEE}"/>
</file>

<file path=docProps/app.xml><?xml version="1.0" encoding="utf-8"?>
<Properties xmlns="http://schemas.openxmlformats.org/officeDocument/2006/extended-properties" xmlns:vt="http://schemas.openxmlformats.org/officeDocument/2006/docPropsVTypes">
  <TotalTime>10093</TotalTime>
  <Words>734</Words>
  <Application>Microsoft Office PowerPoint</Application>
  <PresentationFormat>On-screen Show (4:3)</PresentationFormat>
  <Paragraphs>25</Paragraphs>
  <Slides>4</Slides>
  <Notes>4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Worksheet</vt:lpstr>
      <vt:lpstr>Supplementary data</vt:lpstr>
      <vt:lpstr>Figure S1. Optimization of a method for the isolation of gastric LPMC</vt:lpstr>
      <vt:lpstr>Figure S2. Comparison of cytokine levels between normal and “mild inflammation” gastric pathology volunteers.</vt:lpstr>
      <vt:lpstr>PowerPoint Presentation</vt:lpstr>
    </vt:vector>
  </TitlesOfParts>
  <Company>UM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racterization and functional properties of gastric lamina propria mononuclear cells from H. pylori negative children, adults and the elderly</dc:title>
  <dc:creator>jbooth</dc:creator>
  <cp:lastModifiedBy>ftoapanta</cp:lastModifiedBy>
  <cp:revision>340</cp:revision>
  <cp:lastPrinted>2013-11-14T20:04:02Z</cp:lastPrinted>
  <dcterms:created xsi:type="dcterms:W3CDTF">2013-09-17T15:32:44Z</dcterms:created>
  <dcterms:modified xsi:type="dcterms:W3CDTF">2014-04-18T03:08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F9D9197C5E49247BB3420E7F536A978</vt:lpwstr>
  </property>
</Properties>
</file>